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 bookmarkIdSeed="24">
  <p:sldMasterIdLst>
    <p:sldMasterId id="2147483840" r:id="rId1"/>
  </p:sldMasterIdLst>
  <p:notesMasterIdLst>
    <p:notesMasterId r:id="rId3"/>
  </p:notesMasterIdLst>
  <p:sldIdLst>
    <p:sldId id="324" r:id="rId2"/>
  </p:sldIdLst>
  <p:sldSz cx="731520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11CD8B72-5FF1-4F32-8C2C-D7B4478E4F1D}">
          <p14:sldIdLst>
            <p14:sldId id="324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27FB36E-97C1-D6CC-FC60-8D30DA5DA027}" name="Arik Davidyan" initials="AD" userId="S::davidyana@omrf.org::8ca9df27-1e11-474e-a10a-be4812d5a88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830" autoAdjust="0"/>
    <p:restoredTop sz="93645" autoAdjust="0"/>
  </p:normalViewPr>
  <p:slideViewPr>
    <p:cSldViewPr snapToGrid="0">
      <p:cViewPr varScale="1">
        <p:scale>
          <a:sx n="111" d="100"/>
          <a:sy n="111" d="100"/>
        </p:scale>
        <p:origin x="4396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DA46E605-F6B1-403E-A899-FABDB04BC04A}" type="datetimeFigureOut">
              <a:rPr lang="en-US" smtClean="0"/>
              <a:t>3/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3788" y="1162050"/>
            <a:ext cx="22828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34F2219B-4F43-4EA6-982C-2FB4872F3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240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3326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3429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9885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719311A-ACB0-1F7B-D2CB-EC637A3F6E17}"/>
              </a:ext>
            </a:extLst>
          </p:cNvPr>
          <p:cNvCxnSpPr/>
          <p:nvPr userDrawn="1"/>
        </p:nvCxnSpPr>
        <p:spPr>
          <a:xfrm>
            <a:off x="870948" y="1477978"/>
            <a:ext cx="5764513" cy="0"/>
          </a:xfrm>
          <a:prstGeom prst="line">
            <a:avLst/>
          </a:prstGeom>
          <a:ln w="3175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4926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804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6735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08630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6490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3709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8130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3/1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3108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87A34-81AB-432B-8DAE-1953F412C126}" type="datetimeFigureOut">
              <a:rPr lang="en-US" smtClean="0"/>
              <a:pPr/>
              <a:t>3/1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4732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BD539F1-3058-3EE2-44AD-6DBA9455920A}"/>
              </a:ext>
            </a:extLst>
          </p:cNvPr>
          <p:cNvGraphicFramePr>
            <a:graphicFrameLocks noGrp="1"/>
          </p:cNvGraphicFramePr>
          <p:nvPr/>
        </p:nvGraphicFramePr>
        <p:xfrm>
          <a:off x="224287" y="86264"/>
          <a:ext cx="6849371" cy="752174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39223">
                  <a:extLst>
                    <a:ext uri="{9D8B030D-6E8A-4147-A177-3AD203B41FA5}">
                      <a16:colId xmlns:a16="http://schemas.microsoft.com/office/drawing/2014/main" val="1154295921"/>
                    </a:ext>
                  </a:extLst>
                </a:gridCol>
                <a:gridCol w="1963565">
                  <a:extLst>
                    <a:ext uri="{9D8B030D-6E8A-4147-A177-3AD203B41FA5}">
                      <a16:colId xmlns:a16="http://schemas.microsoft.com/office/drawing/2014/main" val="264624756"/>
                    </a:ext>
                  </a:extLst>
                </a:gridCol>
                <a:gridCol w="739223">
                  <a:extLst>
                    <a:ext uri="{9D8B030D-6E8A-4147-A177-3AD203B41FA5}">
                      <a16:colId xmlns:a16="http://schemas.microsoft.com/office/drawing/2014/main" val="1118744170"/>
                    </a:ext>
                  </a:extLst>
                </a:gridCol>
                <a:gridCol w="438914">
                  <a:extLst>
                    <a:ext uri="{9D8B030D-6E8A-4147-A177-3AD203B41FA5}">
                      <a16:colId xmlns:a16="http://schemas.microsoft.com/office/drawing/2014/main" val="2125053975"/>
                    </a:ext>
                  </a:extLst>
                </a:gridCol>
                <a:gridCol w="739223">
                  <a:extLst>
                    <a:ext uri="{9D8B030D-6E8A-4147-A177-3AD203B41FA5}">
                      <a16:colId xmlns:a16="http://schemas.microsoft.com/office/drawing/2014/main" val="3733348862"/>
                    </a:ext>
                  </a:extLst>
                </a:gridCol>
                <a:gridCol w="1490000">
                  <a:extLst>
                    <a:ext uri="{9D8B030D-6E8A-4147-A177-3AD203B41FA5}">
                      <a16:colId xmlns:a16="http://schemas.microsoft.com/office/drawing/2014/main" val="818841305"/>
                    </a:ext>
                  </a:extLst>
                </a:gridCol>
                <a:gridCol w="739223">
                  <a:extLst>
                    <a:ext uri="{9D8B030D-6E8A-4147-A177-3AD203B41FA5}">
                      <a16:colId xmlns:a16="http://schemas.microsoft.com/office/drawing/2014/main" val="2297143278"/>
                    </a:ext>
                  </a:extLst>
                </a:gridCol>
              </a:tblGrid>
              <a:tr h="86645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Complex 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Complex 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91157678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Prote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</a:rPr>
                        <a:t>Peptid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NE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Prote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Peptid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NE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0364409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HPDLPIL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yt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DVNYGWL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</a:rPr>
                        <a:t>1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6584565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Ndufa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VSLNNLSAAEVT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yc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GLLSSLDHTS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1347606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TPYNYPVPV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c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NGAGYFLEHLAF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9973693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GPNEQY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c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SGMFWL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4304535"/>
                  </a:ext>
                </a:extLst>
              </a:tr>
              <a:tr h="13848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YSVNVDY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c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ALISHLDGTTPVCEDIG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59488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KLENLLQGGEVEEVILQAE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4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c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ITSEELHYFVQNHFTS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4425541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TILYT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c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ALANPLYCPDY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8797500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VDLLVI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RLPENLYND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87173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FHETETPRP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SQTEEDCTEELFDFLH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4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8296462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AESSAVAAT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f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EIDQEAAVEVSQL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118865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EVVPPSIIMSSQ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f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SGPFAPVLSATS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03621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NWASGQDLQA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FDQGADAVYDYINEG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3772052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VSSAVL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r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LYSLLF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839954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VNGCALNFF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Uqcr1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ILDWVPYING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457135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FDFEDVFVNIP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Uqcc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APTRPEE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930439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LNHFANY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Ttc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DEFSVQH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702382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VEDIEYLNY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Complex 4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541974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YGLLASILGD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</a:rPr>
                        <a:t>Protein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</a:rPr>
                        <a:t>Peptid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NE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0209319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EGWELFATP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tco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FSWLATLHGGNI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974064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a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NVSATPEQYVPYSTT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tco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VLPMELP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2546143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b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LAILQIESE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Mtco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DAIPG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2627769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b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WNNFL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4i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DYPLPDVAHV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067348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b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DYCAHYL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Cox4i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DWSSLS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3189430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b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ELEQFTQV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5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NDFASAV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02892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b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DQEIINIIQ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Cox5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SGGGVPTDEEQATGL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3177389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b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RTPAPSPQTSIPNPITYLT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</a:rPr>
                        <a:t>3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5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GVGALAAQAL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3653230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b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VIAPSGV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6a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GDHGGAGANTW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6876851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c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YAEILEPFHPV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6b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APFDS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5801332"/>
                  </a:ext>
                </a:extLst>
              </a:tr>
              <a:tr h="9087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YSLFGAL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Cox6b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NCWQNYLDFH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8717389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SIILDPLT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6b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GGDVSVCEWY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625578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STSITQTQL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6b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SLCPVSWVSAWDD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6426255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EAPLFN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6b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IAEGTFPG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2846043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ALIGSPVDLTY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Cox6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YADFY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4383478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LFGEIT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Complex 5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2559465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SLADLTAVDVPT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</a:rPr>
                        <a:t>Protein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>
                          <a:effectLst/>
                        </a:rPr>
                        <a:t>Peptid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NE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523820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VAEPVELAQEF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a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ESAFLSHVVSQHQSLLGNI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</a:rPr>
                        <a:t>4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6561688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GISLD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a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HALIIYDDL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7534273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HFIFLSAEQPY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a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SIAIDTIINQ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0037648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GTCGYCGLQF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a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GTAEMSSILE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890322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DDLINW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LSQPFQVAEVFTGHMG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27776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HQSVAATGSPSSTQSAVS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4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EGNDLYHEMIESGVINL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4492668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s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QADVMIVAGTLTN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Atp5c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YGTGSLALYE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5134369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v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YLVVNADEGEPGTC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c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LTLTFN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</a:rPr>
                        <a:t>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2831612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v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ACDSDYDFDVFVV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c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THSDQFLVSF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5319934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v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DSDSILETLQ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Atp5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AQSELSGAADEAA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4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2194345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dufv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AAAVLPVLDLAQ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3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IEANEALV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9873940"/>
                  </a:ext>
                </a:extLst>
              </a:tr>
              <a:tr h="86645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Complex 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FSQICA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174290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Protei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Peptid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</a:rPr>
                        <a:t>NEH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f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PLPPLPEYGG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581123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dh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GEGGILINSQG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</a:rPr>
                        <a:t>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Atp5f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NIALALEVTY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6085195"/>
                  </a:ext>
                </a:extLst>
              </a:tr>
              <a:tr h="14369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dh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VSQLYGDLQHL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ASLSEKPPAIDWAYY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</a:rPr>
                        <a:t>3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073466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dh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SIEPYL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SWNETFHT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6343991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dh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DEFTE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CAQFVTGSQ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4653193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dh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NTSSNRPVSPHLTIY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VPPVQVSPLI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5520682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ELAEAEDVSIF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6128840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j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DFTPSGIAGAF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408996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j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ELPSWILM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6560235"/>
                  </a:ext>
                </a:extLst>
              </a:tr>
              <a:tr h="35801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ATFWHYA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8398057"/>
                  </a:ext>
                </a:extLst>
              </a:tr>
              <a:tr h="8664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tp5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LVRPPVQVYGIEG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</a:rPr>
                        <a:t>2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00" marR="2900" marT="290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915478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4109520-B777-C295-1C5C-4357C62DB214}"/>
              </a:ext>
            </a:extLst>
          </p:cNvPr>
          <p:cNvSpPr txBox="1"/>
          <p:nvPr/>
        </p:nvSpPr>
        <p:spPr>
          <a:xfrm>
            <a:off x="224287" y="7707057"/>
            <a:ext cx="673635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: Validation peptides and number of exchangeable hydrogens (NEH). </a:t>
            </a:r>
          </a:p>
        </p:txBody>
      </p:sp>
    </p:spTree>
    <p:extLst>
      <p:ext uri="{BB962C8B-B14F-4D97-AF65-F5344CB8AC3E}">
        <p14:creationId xmlns:p14="http://schemas.microsoft.com/office/powerpoint/2010/main" val="4242235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403</TotalTime>
  <Words>459</Words>
  <Application>Microsoft Office PowerPoint</Application>
  <PresentationFormat>Custom</PresentationFormat>
  <Paragraphs>3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formin treatment effects on protein turnover in the HCR/LCR rat model</dc:title>
  <dc:creator>Matt Bubak</dc:creator>
  <cp:lastModifiedBy>Matthew Bubak</cp:lastModifiedBy>
  <cp:revision>323</cp:revision>
  <cp:lastPrinted>2023-12-15T16:29:23Z</cp:lastPrinted>
  <dcterms:created xsi:type="dcterms:W3CDTF">2022-07-14T20:18:29Z</dcterms:created>
  <dcterms:modified xsi:type="dcterms:W3CDTF">2024-03-01T16:38:37Z</dcterms:modified>
</cp:coreProperties>
</file>